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38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ylor, Christopher A. (CDC/NCIRD/CORVD)" userId="d5235d67-467a-405e-9bf3-737b0972e886" providerId="ADAL" clId="{1F65C964-6A4B-4A94-A89D-6A11D897BA16}"/>
    <pc:docChg chg="modSld">
      <pc:chgData name="Taylor, Christopher A. (CDC/NCIRD/CORVD)" userId="d5235d67-467a-405e-9bf3-737b0972e886" providerId="ADAL" clId="{1F65C964-6A4B-4A94-A89D-6A11D897BA16}" dt="2024-09-23T14:23:10.927" v="3" actId="20577"/>
      <pc:docMkLst>
        <pc:docMk/>
      </pc:docMkLst>
      <pc:sldChg chg="modSp mod">
        <pc:chgData name="Taylor, Christopher A. (CDC/NCIRD/CORVD)" userId="d5235d67-467a-405e-9bf3-737b0972e886" providerId="ADAL" clId="{1F65C964-6A4B-4A94-A89D-6A11D897BA16}" dt="2024-09-23T14:23:10.927" v="3" actId="20577"/>
        <pc:sldMkLst>
          <pc:docMk/>
          <pc:sldMk cId="820812823" sldId="264"/>
        </pc:sldMkLst>
        <pc:spChg chg="mod">
          <ac:chgData name="Taylor, Christopher A. (CDC/NCIRD/CORVD)" userId="d5235d67-467a-405e-9bf3-737b0972e886" providerId="ADAL" clId="{1F65C964-6A4B-4A94-A89D-6A11D897BA16}" dt="2024-09-23T14:23:07.754" v="2" actId="20577"/>
          <ac:spMkLst>
            <pc:docMk/>
            <pc:sldMk cId="820812823" sldId="264"/>
            <ac:spMk id="21" creationId="{D0DA439E-9D45-68E6-7818-5B6BC14FF898}"/>
          </ac:spMkLst>
        </pc:spChg>
        <pc:spChg chg="mod">
          <ac:chgData name="Taylor, Christopher A. (CDC/NCIRD/CORVD)" userId="d5235d67-467a-405e-9bf3-737b0972e886" providerId="ADAL" clId="{1F65C964-6A4B-4A94-A89D-6A11D897BA16}" dt="2024-09-23T14:18:19.682" v="1" actId="6549"/>
          <ac:spMkLst>
            <pc:docMk/>
            <pc:sldMk cId="820812823" sldId="264"/>
            <ac:spMk id="26" creationId="{2365F8F6-F363-E5A5-0FB7-8374288ABDED}"/>
          </ac:spMkLst>
        </pc:spChg>
        <pc:spChg chg="mod">
          <ac:chgData name="Taylor, Christopher A. (CDC/NCIRD/CORVD)" userId="d5235d67-467a-405e-9bf3-737b0972e886" providerId="ADAL" clId="{1F65C964-6A4B-4A94-A89D-6A11D897BA16}" dt="2024-09-23T14:23:10.927" v="3" actId="20577"/>
          <ac:spMkLst>
            <pc:docMk/>
            <pc:sldMk cId="820812823" sldId="264"/>
            <ac:spMk id="35" creationId="{F6FFBF2D-4090-B37D-8016-0A878E8D76F0}"/>
          </ac:spMkLst>
        </pc:spChg>
      </pc:sldChg>
    </pc:docChg>
  </pc:docChgLst>
  <pc:docChgLst>
    <pc:chgData name="Taylor, Christopher A. (CDC/NCIRD/CORVD)" userId="d5235d67-467a-405e-9bf3-737b0972e886" providerId="ADAL" clId="{03B3843C-AC9E-4179-A9CF-F75895450005}"/>
    <pc:docChg chg="modSld">
      <pc:chgData name="Taylor, Christopher A. (CDC/NCIRD/CORVD)" userId="d5235d67-467a-405e-9bf3-737b0972e886" providerId="ADAL" clId="{03B3843C-AC9E-4179-A9CF-F75895450005}" dt="2024-09-16T19:50:43.534" v="7" actId="6549"/>
      <pc:docMkLst>
        <pc:docMk/>
      </pc:docMkLst>
      <pc:sldChg chg="modSp mod">
        <pc:chgData name="Taylor, Christopher A. (CDC/NCIRD/CORVD)" userId="d5235d67-467a-405e-9bf3-737b0972e886" providerId="ADAL" clId="{03B3843C-AC9E-4179-A9CF-F75895450005}" dt="2024-09-16T19:50:43.534" v="7" actId="6549"/>
        <pc:sldMkLst>
          <pc:docMk/>
          <pc:sldMk cId="820812823" sldId="264"/>
        </pc:sldMkLst>
        <pc:spChg chg="mod">
          <ac:chgData name="Taylor, Christopher A. (CDC/NCIRD/CORVD)" userId="d5235d67-467a-405e-9bf3-737b0972e886" providerId="ADAL" clId="{03B3843C-AC9E-4179-A9CF-F75895450005}" dt="2024-09-16T19:50:43.534" v="7" actId="6549"/>
          <ac:spMkLst>
            <pc:docMk/>
            <pc:sldMk cId="820812823" sldId="264"/>
            <ac:spMk id="21" creationId="{D0DA439E-9D45-68E6-7818-5B6BC14FF898}"/>
          </ac:spMkLst>
        </pc:spChg>
        <pc:spChg chg="mod">
          <ac:chgData name="Taylor, Christopher A. (CDC/NCIRD/CORVD)" userId="d5235d67-467a-405e-9bf3-737b0972e886" providerId="ADAL" clId="{03B3843C-AC9E-4179-A9CF-F75895450005}" dt="2024-09-16T19:48:59.806" v="2" actId="57"/>
          <ac:spMkLst>
            <pc:docMk/>
            <pc:sldMk cId="820812823" sldId="264"/>
            <ac:spMk id="26" creationId="{2365F8F6-F363-E5A5-0FB7-8374288ABDED}"/>
          </ac:spMkLst>
        </pc:spChg>
        <pc:spChg chg="mod">
          <ac:chgData name="Taylor, Christopher A. (CDC/NCIRD/CORVD)" userId="d5235d67-467a-405e-9bf3-737b0972e886" providerId="ADAL" clId="{03B3843C-AC9E-4179-A9CF-F75895450005}" dt="2024-09-16T19:49:22.586" v="4" actId="20578"/>
          <ac:spMkLst>
            <pc:docMk/>
            <pc:sldMk cId="820812823" sldId="264"/>
            <ac:spMk id="35" creationId="{F6FFBF2D-4090-B37D-8016-0A878E8D76F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1A6D40-9C0A-A8E2-7610-1E5413A53E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06119A-1D56-8212-63B9-62FDAB6775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2A9A8-55C9-2E77-8F02-C154902CA6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4BDA79-280C-7BA9-6627-B3F19A4C90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DC600A-B4A3-0346-FA11-EEC27FE4D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679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4DA793-E0C3-8711-ECF2-262F02F718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74BBC-AD4A-F56B-593E-C30A7C4A0C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C4B7A0-799A-A1A9-D235-584679C3C5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9FD248-F053-2D9C-FDCD-CFA8FF6519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F08BC9-C4BF-AD43-BDEE-73A907DEB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542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A260848-F759-4DF6-8832-21CDBEE906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479754-4C94-7045-DE43-DC95C86545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D7EDBE-B07E-6805-C8A0-893FB31FD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34B9AE-3667-BFD2-961A-944A12C5B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B088F-131B-A3E4-2EC0-40C43FDAD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4300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93B144-0B82-16B1-5AA1-06A8EB2D4D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7DD4B2-65B7-8B49-3A1D-1F81348655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662D23-EB85-175F-E001-468AC2445F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89D052-B3AD-081F-DB53-92F9E180A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5C0D8C-AE39-DAD7-3CE9-67BE7D1150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62661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4AC62-B739-D6B9-6E10-A07DFE35C4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F74947-B885-372A-7A76-A63236EFED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B9BA46-B1E6-CC30-B11D-519E6D0AF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F7797-1BBD-E719-80D5-6DAD6F192E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BC60FE9-FBAD-9B0A-6817-EAFF28C3D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037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DD1885-27F1-8A91-A9F8-39DD8C729D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903D83-33B0-4562-D5BA-C5F452EEEC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BDD36EB-4BB9-8EBD-CE24-8D8629003A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95C43E-F8E8-DF52-8637-ED8B9839C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27C53B-CF72-2DC5-5E4C-C2FA5E9DA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776D1F-0571-7B61-0541-8B4EB05BB7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2565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A54BA-DA6A-D217-7B0B-5D6948E1F1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FAFC58-A4F1-FB77-49F6-96DE040B46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03E6057-C25A-64DB-BD9F-A2A9606618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EF3F26-C5BD-3257-EFEE-B063A97CC3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AC8FB7C-162C-7F87-074E-76B9C5DBAF8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92165C-0398-A0CD-A1C5-83146A4C5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DDA49A-75EA-1513-9B69-2E821DB19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0C9AF6F-3938-4178-26E2-387B8A445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403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E1EF10-52A2-1682-C8F1-DD1D56D0FA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8214445-DB1F-721A-7C0C-1649884AAA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9059CC-BAF5-69D7-A553-2556481B2B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06FD7B-3FE5-F508-C2E5-8622102350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88414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2F501DB-93CC-B0C8-257E-BC8DF94CA0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FCD20D9-2D34-F92E-3E0A-2F0426902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F673797-9304-9AF0-8288-F1AA4E09D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495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B95A8A-CA29-CB38-7D05-8F187EC88B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08D5E8-638F-58BC-9C32-5D20B24D69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62E1AF-E592-6E46-0D6C-F5B94E5B40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6C8187-50A7-2C0B-3AC4-7C8D9EFF5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430279-E0F0-66BB-5D01-FE6356ACD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C96E08-FA57-3D8B-5731-8D2EEEAEF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2879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612CF-8669-9B92-DAFC-3230AA8FAF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B068C4-5A24-1AC7-4846-42C6167C58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D6510E9-2038-29B9-4AC8-4828CFD38D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554ABC-F7AC-85DB-84DC-AA7BF0E6A4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085F0D-F9A9-8778-DA1E-3F7E394253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C675D6-8773-4992-E0E1-B45B347FD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117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9CCA02D-1B73-4B56-23CA-44885503A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3B9868-610A-546C-FCC9-CB9CE4A95C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357887-9228-0AC1-658E-FAF8412CDF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91E65-BE2A-477C-A797-4FEF6BE522D5}" type="datetimeFigureOut">
              <a:rPr lang="en-US" smtClean="0"/>
              <a:t>9/2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4D7F95-70F3-C652-ABD8-8EE6650385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19ECBA-5023-E1CE-357F-6A9CAA0CB3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7585E-A69E-46E8-8750-C86C1CD78B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238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B949DAEF-CCEB-FC96-9974-471CE517DEA9}"/>
              </a:ext>
            </a:extLst>
          </p:cNvPr>
          <p:cNvGrpSpPr/>
          <p:nvPr/>
        </p:nvGrpSpPr>
        <p:grpSpPr>
          <a:xfrm>
            <a:off x="288426" y="882614"/>
            <a:ext cx="11615148" cy="5092773"/>
            <a:chOff x="398707" y="391930"/>
            <a:chExt cx="11615148" cy="5092773"/>
          </a:xfrm>
        </p:grpSpPr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0E59A32F-42FF-11C4-558C-13FD3DF57A85}"/>
                </a:ext>
              </a:extLst>
            </p:cNvPr>
            <p:cNvSpPr/>
            <p:nvPr/>
          </p:nvSpPr>
          <p:spPr>
            <a:xfrm>
              <a:off x="4690519" y="2600634"/>
              <a:ext cx="1828800" cy="136866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Hospitalization with COVID-19-related outcomes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1CFB3D88-B54B-C5D0-0804-9128D2DE556A}"/>
                </a:ext>
              </a:extLst>
            </p:cNvPr>
            <p:cNvCxnSpPr>
              <a:cxnSpLocks/>
              <a:stCxn id="21" idx="3"/>
              <a:endCxn id="26" idx="1"/>
            </p:cNvCxnSpPr>
            <p:nvPr/>
          </p:nvCxnSpPr>
          <p:spPr>
            <a:xfrm flipV="1">
              <a:off x="2224216" y="1082123"/>
              <a:ext cx="1035699" cy="415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7710058D-07C8-E636-B982-3704F9D778AB}"/>
                </a:ext>
              </a:extLst>
            </p:cNvPr>
            <p:cNvSpPr/>
            <p:nvPr/>
          </p:nvSpPr>
          <p:spPr>
            <a:xfrm>
              <a:off x="3633862" y="4895300"/>
              <a:ext cx="3938822" cy="58940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Likely COVID-19-attributable hospitalization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D0DA439E-9D45-68E6-7818-5B6BC14FF898}"/>
                </a:ext>
              </a:extLst>
            </p:cNvPr>
            <p:cNvSpPr/>
            <p:nvPr/>
          </p:nvSpPr>
          <p:spPr>
            <a:xfrm>
              <a:off x="398707" y="401943"/>
              <a:ext cx="1825509" cy="136865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Was the presenting complaint COVID-19-related?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id="{53D93171-C02F-073F-6761-FAE892F7AA60}"/>
                </a:ext>
              </a:extLst>
            </p:cNvPr>
            <p:cNvSpPr/>
            <p:nvPr/>
          </p:nvSpPr>
          <p:spPr>
            <a:xfrm>
              <a:off x="1630213" y="2589697"/>
              <a:ext cx="1828800" cy="136866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Hospitalization with COVID-19-related presenting complaint</a:t>
              </a:r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2365F8F6-F363-E5A5-0FB7-8374288ABDED}"/>
                </a:ext>
              </a:extLst>
            </p:cNvPr>
            <p:cNvSpPr/>
            <p:nvPr/>
          </p:nvSpPr>
          <p:spPr>
            <a:xfrm>
              <a:off x="3259915" y="397793"/>
              <a:ext cx="1825509" cy="136865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Did the hospitalization record include a respiratory- or coagulopathy-related discharge diagnosis?</a:t>
              </a:r>
            </a:p>
          </p:txBody>
        </p: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61E50A2D-8D8B-343F-CD64-92510B5DA00A}"/>
                </a:ext>
              </a:extLst>
            </p:cNvPr>
            <p:cNvCxnSpPr>
              <a:cxnSpLocks/>
              <a:stCxn id="26" idx="3"/>
              <a:endCxn id="29" idx="1"/>
            </p:cNvCxnSpPr>
            <p:nvPr/>
          </p:nvCxnSpPr>
          <p:spPr>
            <a:xfrm flipV="1">
              <a:off x="5085424" y="1082122"/>
              <a:ext cx="1035699" cy="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11EFE657-64C8-5026-6600-03CE8DD630A3}"/>
                </a:ext>
              </a:extLst>
            </p:cNvPr>
            <p:cNvSpPr/>
            <p:nvPr/>
          </p:nvSpPr>
          <p:spPr>
            <a:xfrm>
              <a:off x="6121123" y="397792"/>
              <a:ext cx="1825509" cy="136865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Did the hospitalization record include COVID-19 (code U07.1) as the principal ICD-10-CM discharge diagnosis code?</a:t>
              </a:r>
            </a:p>
          </p:txBody>
        </p: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BC90B9C4-46F2-AEA1-C1FF-BCEBB2A8881A}"/>
                </a:ext>
              </a:extLst>
            </p:cNvPr>
            <p:cNvCxnSpPr>
              <a:cxnSpLocks/>
              <a:stCxn id="29" idx="3"/>
              <a:endCxn id="35" idx="1"/>
            </p:cNvCxnSpPr>
            <p:nvPr/>
          </p:nvCxnSpPr>
          <p:spPr>
            <a:xfrm flipV="1">
              <a:off x="7946632" y="1076260"/>
              <a:ext cx="1035699" cy="5862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tangle 34">
              <a:extLst>
                <a:ext uri="{FF2B5EF4-FFF2-40B4-BE49-F238E27FC236}">
                  <a16:creationId xmlns:a16="http://schemas.microsoft.com/office/drawing/2014/main" id="{F6FFBF2D-4090-B37D-8016-0A878E8D76F0}"/>
                </a:ext>
              </a:extLst>
            </p:cNvPr>
            <p:cNvSpPr/>
            <p:nvPr/>
          </p:nvSpPr>
          <p:spPr>
            <a:xfrm>
              <a:off x="8982331" y="391930"/>
              <a:ext cx="3031524" cy="1368659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Did the hospitalization record indicate in-hospital treatment with (a) medications recommended for the therapeutic management of hospitalized adults with COVID-19 or (b) systemic steroids?</a:t>
              </a: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D35E6B82-D4D8-DE25-854C-0F0D237CAFFC}"/>
                </a:ext>
              </a:extLst>
            </p:cNvPr>
            <p:cNvSpPr/>
            <p:nvPr/>
          </p:nvSpPr>
          <p:spPr>
            <a:xfrm>
              <a:off x="7750825" y="2587766"/>
              <a:ext cx="1828800" cy="1368665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Hospitalization with COVID-19-related treatment</a:t>
              </a:r>
            </a:p>
          </p:txBody>
        </p:sp>
        <p:sp>
          <p:nvSpPr>
            <p:cNvPr id="47" name="Rectangle 46">
              <a:extLst>
                <a:ext uri="{FF2B5EF4-FFF2-40B4-BE49-F238E27FC236}">
                  <a16:creationId xmlns:a16="http://schemas.microsoft.com/office/drawing/2014/main" id="{B5D72BC3-3C19-3FD0-9690-4E357641FC72}"/>
                </a:ext>
              </a:extLst>
            </p:cNvPr>
            <p:cNvSpPr/>
            <p:nvPr/>
          </p:nvSpPr>
          <p:spPr>
            <a:xfrm>
              <a:off x="9193604" y="4895300"/>
              <a:ext cx="2608977" cy="589403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Hospitalization likely not attributable to COVID-19</a:t>
              </a:r>
            </a:p>
          </p:txBody>
        </p:sp>
        <p:cxnSp>
          <p:nvCxnSpPr>
            <p:cNvPr id="49" name="Connector: Elbow 48">
              <a:extLst>
                <a:ext uri="{FF2B5EF4-FFF2-40B4-BE49-F238E27FC236}">
                  <a16:creationId xmlns:a16="http://schemas.microsoft.com/office/drawing/2014/main" id="{92215BF4-EF12-E40A-3A71-21D2A145F468}"/>
                </a:ext>
              </a:extLst>
            </p:cNvPr>
            <p:cNvCxnSpPr>
              <a:stCxn id="21" idx="2"/>
              <a:endCxn id="22" idx="1"/>
            </p:cNvCxnSpPr>
            <p:nvPr/>
          </p:nvCxnSpPr>
          <p:spPr>
            <a:xfrm rot="16200000" flipH="1">
              <a:off x="719123" y="2362940"/>
              <a:ext cx="1503428" cy="318751"/>
            </a:xfrm>
            <a:prstGeom prst="bentConnector2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ctor: Elbow 50">
              <a:extLst>
                <a:ext uri="{FF2B5EF4-FFF2-40B4-BE49-F238E27FC236}">
                  <a16:creationId xmlns:a16="http://schemas.microsoft.com/office/drawing/2014/main" id="{7B1606BB-2AA1-F41F-AFCA-88F1E3E9F0DD}"/>
                </a:ext>
              </a:extLst>
            </p:cNvPr>
            <p:cNvCxnSpPr>
              <a:stCxn id="26" idx="2"/>
              <a:endCxn id="8" idx="1"/>
            </p:cNvCxnSpPr>
            <p:nvPr/>
          </p:nvCxnSpPr>
          <p:spPr>
            <a:xfrm rot="16200000" flipH="1">
              <a:off x="3672337" y="2266784"/>
              <a:ext cx="1518515" cy="517849"/>
            </a:xfrm>
            <a:prstGeom prst="bentConnector2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ctor: Elbow 52">
              <a:extLst>
                <a:ext uri="{FF2B5EF4-FFF2-40B4-BE49-F238E27FC236}">
                  <a16:creationId xmlns:a16="http://schemas.microsoft.com/office/drawing/2014/main" id="{5A9BF281-BABD-BA47-C6CC-B9E5F82BC01D}"/>
                </a:ext>
              </a:extLst>
            </p:cNvPr>
            <p:cNvCxnSpPr>
              <a:stCxn id="29" idx="2"/>
              <a:endCxn id="8" idx="3"/>
            </p:cNvCxnSpPr>
            <p:nvPr/>
          </p:nvCxnSpPr>
          <p:spPr>
            <a:xfrm rot="5400000">
              <a:off x="6017341" y="2268430"/>
              <a:ext cx="1518516" cy="514559"/>
            </a:xfrm>
            <a:prstGeom prst="bentConnector2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Connector: Elbow 54">
              <a:extLst>
                <a:ext uri="{FF2B5EF4-FFF2-40B4-BE49-F238E27FC236}">
                  <a16:creationId xmlns:a16="http://schemas.microsoft.com/office/drawing/2014/main" id="{B2F69DC5-5282-47BD-A641-A95CC400F55A}"/>
                </a:ext>
              </a:extLst>
            </p:cNvPr>
            <p:cNvCxnSpPr>
              <a:cxnSpLocks/>
              <a:stCxn id="35" idx="2"/>
              <a:endCxn id="36" idx="3"/>
            </p:cNvCxnSpPr>
            <p:nvPr/>
          </p:nvCxnSpPr>
          <p:spPr>
            <a:xfrm rot="5400000">
              <a:off x="9283104" y="2057110"/>
              <a:ext cx="1511510" cy="918468"/>
            </a:xfrm>
            <a:prstGeom prst="bentConnector2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or: Elbow 56">
              <a:extLst>
                <a:ext uri="{FF2B5EF4-FFF2-40B4-BE49-F238E27FC236}">
                  <a16:creationId xmlns:a16="http://schemas.microsoft.com/office/drawing/2014/main" id="{98BFC589-3994-7E66-E9BA-31BD52D0C1FC}"/>
                </a:ext>
              </a:extLst>
            </p:cNvPr>
            <p:cNvCxnSpPr>
              <a:stCxn id="22" idx="2"/>
              <a:endCxn id="16" idx="1"/>
            </p:cNvCxnSpPr>
            <p:nvPr/>
          </p:nvCxnSpPr>
          <p:spPr>
            <a:xfrm rot="16200000" flipH="1">
              <a:off x="2473417" y="4029557"/>
              <a:ext cx="1231640" cy="1089249"/>
            </a:xfrm>
            <a:prstGeom prst="bentConnector2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Connector: Elbow 58">
              <a:extLst>
                <a:ext uri="{FF2B5EF4-FFF2-40B4-BE49-F238E27FC236}">
                  <a16:creationId xmlns:a16="http://schemas.microsoft.com/office/drawing/2014/main" id="{50DA9414-F03F-967F-8E24-AB9216357F90}"/>
                </a:ext>
              </a:extLst>
            </p:cNvPr>
            <p:cNvCxnSpPr>
              <a:stCxn id="36" idx="2"/>
              <a:endCxn id="16" idx="3"/>
            </p:cNvCxnSpPr>
            <p:nvPr/>
          </p:nvCxnSpPr>
          <p:spPr>
            <a:xfrm rot="5400000">
              <a:off x="7502170" y="4026946"/>
              <a:ext cx="1233571" cy="1092541"/>
            </a:xfrm>
            <a:prstGeom prst="bentConnector2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Arrow Connector 60">
              <a:extLst>
                <a:ext uri="{FF2B5EF4-FFF2-40B4-BE49-F238E27FC236}">
                  <a16:creationId xmlns:a16="http://schemas.microsoft.com/office/drawing/2014/main" id="{A0966E98-422A-F8D8-4DEE-89FBA22846C5}"/>
                </a:ext>
              </a:extLst>
            </p:cNvPr>
            <p:cNvCxnSpPr>
              <a:stCxn id="8" idx="2"/>
              <a:endCxn id="16" idx="0"/>
            </p:cNvCxnSpPr>
            <p:nvPr/>
          </p:nvCxnSpPr>
          <p:spPr>
            <a:xfrm flipH="1">
              <a:off x="5603273" y="3969299"/>
              <a:ext cx="1646" cy="92600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Arrow Connector 63">
              <a:extLst>
                <a:ext uri="{FF2B5EF4-FFF2-40B4-BE49-F238E27FC236}">
                  <a16:creationId xmlns:a16="http://schemas.microsoft.com/office/drawing/2014/main" id="{7C20BA15-9333-B0F1-F320-2EBDD6E2B9CC}"/>
                </a:ext>
              </a:extLst>
            </p:cNvPr>
            <p:cNvCxnSpPr>
              <a:cxnSpLocks/>
            </p:cNvCxnSpPr>
            <p:nvPr/>
          </p:nvCxnSpPr>
          <p:spPr>
            <a:xfrm>
              <a:off x="10799805" y="1760589"/>
              <a:ext cx="0" cy="3134711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FB82532E-8E3E-2CBB-20E0-23D3B976E8D6}"/>
                </a:ext>
              </a:extLst>
            </p:cNvPr>
            <p:cNvSpPr txBox="1"/>
            <p:nvPr/>
          </p:nvSpPr>
          <p:spPr>
            <a:xfrm>
              <a:off x="2404754" y="768482"/>
              <a:ext cx="635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O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9F7626C5-24B2-1D66-D3A1-8FC4B9FB1B2D}"/>
                </a:ext>
              </a:extLst>
            </p:cNvPr>
            <p:cNvSpPr txBox="1"/>
            <p:nvPr/>
          </p:nvSpPr>
          <p:spPr>
            <a:xfrm>
              <a:off x="5285294" y="776421"/>
              <a:ext cx="635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O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B32D267-EA07-875B-D06B-A2178D6034FD}"/>
                </a:ext>
              </a:extLst>
            </p:cNvPr>
            <p:cNvSpPr txBox="1"/>
            <p:nvPr/>
          </p:nvSpPr>
          <p:spPr>
            <a:xfrm>
              <a:off x="8127170" y="776421"/>
              <a:ext cx="635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O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8962B5E8-2B7D-DC09-17BE-2EC99EC7915C}"/>
                </a:ext>
              </a:extLst>
            </p:cNvPr>
            <p:cNvSpPr txBox="1"/>
            <p:nvPr/>
          </p:nvSpPr>
          <p:spPr>
            <a:xfrm>
              <a:off x="10696138" y="3020167"/>
              <a:ext cx="635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NO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7FC2DEB9-F3B8-D613-7F36-55A28ADE7C10}"/>
                </a:ext>
              </a:extLst>
            </p:cNvPr>
            <p:cNvSpPr txBox="1"/>
            <p:nvPr/>
          </p:nvSpPr>
          <p:spPr>
            <a:xfrm>
              <a:off x="790062" y="1804990"/>
              <a:ext cx="635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YES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7449A72E-A94A-D6C8-E2E8-E592A51E3FC6}"/>
                </a:ext>
              </a:extLst>
            </p:cNvPr>
            <p:cNvSpPr txBox="1"/>
            <p:nvPr/>
          </p:nvSpPr>
          <p:spPr>
            <a:xfrm>
              <a:off x="3633862" y="1800841"/>
              <a:ext cx="635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YES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B929181-55DD-4D77-C524-259C7EA36030}"/>
                </a:ext>
              </a:extLst>
            </p:cNvPr>
            <p:cNvSpPr txBox="1"/>
            <p:nvPr/>
          </p:nvSpPr>
          <p:spPr>
            <a:xfrm>
              <a:off x="6494298" y="1800841"/>
              <a:ext cx="635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YES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C994C948-2E41-D6FD-5882-DC444DCAA470}"/>
                </a:ext>
              </a:extLst>
            </p:cNvPr>
            <p:cNvSpPr txBox="1"/>
            <p:nvPr/>
          </p:nvSpPr>
          <p:spPr>
            <a:xfrm>
              <a:off x="9949327" y="1800841"/>
              <a:ext cx="6359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/>
                <a:t>YES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208128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4E73DB1B3A82240AAE4616B9E408885" ma:contentTypeVersion="15" ma:contentTypeDescription="Create a new document." ma:contentTypeScope="" ma:versionID="31a882a0ca9e78c7185939a02ab2d4e7">
  <xsd:schema xmlns:xsd="http://www.w3.org/2001/XMLSchema" xmlns:xs="http://www.w3.org/2001/XMLSchema" xmlns:p="http://schemas.microsoft.com/office/2006/metadata/properties" xmlns:ns2="559fa04e-dbf9-4202-90f7-f9635d81742e" xmlns:ns3="11258c1b-5a8e-46e3-bab0-95e92e5e9835" targetNamespace="http://schemas.microsoft.com/office/2006/metadata/properties" ma:root="true" ma:fieldsID="059323d942d83956d1b8c28356328293" ns2:_="" ns3:_="">
    <xsd:import namespace="559fa04e-dbf9-4202-90f7-f9635d81742e"/>
    <xsd:import namespace="11258c1b-5a8e-46e3-bab0-95e92e5e983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LengthInSeconds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59fa04e-dbf9-4202-90f7-f9635d81742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9353dbe8-8260-4ccf-8219-3d2995e6fa1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3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MediaServiceObjectDetectorVersions" ma:index="21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1258c1b-5a8e-46e3-bab0-95e92e5e9835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b68e2f84-bb39-424c-8323-bdb2ddd19ae9}" ma:internalName="TaxCatchAll" ma:showField="CatchAllData" ma:web="11258c1b-5a8e-46e3-bab0-95e92e5e983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559fa04e-dbf9-4202-90f7-f9635d81742e">
      <Terms xmlns="http://schemas.microsoft.com/office/infopath/2007/PartnerControls"/>
    </lcf76f155ced4ddcb4097134ff3c332f>
    <TaxCatchAll xmlns="11258c1b-5a8e-46e3-bab0-95e92e5e9835" xsi:nil="true"/>
  </documentManagement>
</p:properties>
</file>

<file path=customXml/itemProps1.xml><?xml version="1.0" encoding="utf-8"?>
<ds:datastoreItem xmlns:ds="http://schemas.openxmlformats.org/officeDocument/2006/customXml" ds:itemID="{A09681DF-96DB-41CE-B7AA-B65DB742B39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59fa04e-dbf9-4202-90f7-f9635d81742e"/>
    <ds:schemaRef ds:uri="11258c1b-5a8e-46e3-bab0-95e92e5e983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7324C1C4-D91C-4861-B73F-C42087EC7DC7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40FC79F-2D3F-442C-8C88-52F7C8DAD948}">
  <ds:schemaRefs>
    <ds:schemaRef ds:uri="http://schemas.microsoft.com/office/2006/metadata/properties"/>
    <ds:schemaRef ds:uri="http://schemas.microsoft.com/office/infopath/2007/PartnerControls"/>
    <ds:schemaRef ds:uri="559fa04e-dbf9-4202-90f7-f9635d81742e"/>
    <ds:schemaRef ds:uri="11258c1b-5a8e-46e3-bab0-95e92e5e9835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95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ylor, Christopher A. (CDC/NCIRD/CORVD)</dc:creator>
  <cp:lastModifiedBy>Taylor, Christopher A. (CDC/NCIRD/CORVD)</cp:lastModifiedBy>
  <cp:revision>1</cp:revision>
  <dcterms:created xsi:type="dcterms:W3CDTF">2024-09-16T15:13:26Z</dcterms:created>
  <dcterms:modified xsi:type="dcterms:W3CDTF">2024-09-23T14:23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b94a7b8-f06c-4dfe-bdcc-9b548fd58c31_Enabled">
    <vt:lpwstr>true</vt:lpwstr>
  </property>
  <property fmtid="{D5CDD505-2E9C-101B-9397-08002B2CF9AE}" pid="3" name="MSIP_Label_7b94a7b8-f06c-4dfe-bdcc-9b548fd58c31_SetDate">
    <vt:lpwstr>2024-09-16T15:14:24Z</vt:lpwstr>
  </property>
  <property fmtid="{D5CDD505-2E9C-101B-9397-08002B2CF9AE}" pid="4" name="MSIP_Label_7b94a7b8-f06c-4dfe-bdcc-9b548fd58c31_Method">
    <vt:lpwstr>Privileged</vt:lpwstr>
  </property>
  <property fmtid="{D5CDD505-2E9C-101B-9397-08002B2CF9AE}" pid="5" name="MSIP_Label_7b94a7b8-f06c-4dfe-bdcc-9b548fd58c31_Name">
    <vt:lpwstr>7b94a7b8-f06c-4dfe-bdcc-9b548fd58c31</vt:lpwstr>
  </property>
  <property fmtid="{D5CDD505-2E9C-101B-9397-08002B2CF9AE}" pid="6" name="MSIP_Label_7b94a7b8-f06c-4dfe-bdcc-9b548fd58c31_SiteId">
    <vt:lpwstr>9ce70869-60db-44fd-abe8-d2767077fc8f</vt:lpwstr>
  </property>
  <property fmtid="{D5CDD505-2E9C-101B-9397-08002B2CF9AE}" pid="7" name="MSIP_Label_7b94a7b8-f06c-4dfe-bdcc-9b548fd58c31_ActionId">
    <vt:lpwstr>e5b4d0b5-bb6d-4b3a-8d89-abe6bae63bc1</vt:lpwstr>
  </property>
  <property fmtid="{D5CDD505-2E9C-101B-9397-08002B2CF9AE}" pid="8" name="MSIP_Label_7b94a7b8-f06c-4dfe-bdcc-9b548fd58c31_ContentBits">
    <vt:lpwstr>0</vt:lpwstr>
  </property>
  <property fmtid="{D5CDD505-2E9C-101B-9397-08002B2CF9AE}" pid="9" name="ContentTypeId">
    <vt:lpwstr>0x010100E4E73DB1B3A82240AAE4616B9E408885</vt:lpwstr>
  </property>
  <property fmtid="{D5CDD505-2E9C-101B-9397-08002B2CF9AE}" pid="10" name="MediaServiceImageTags">
    <vt:lpwstr/>
  </property>
</Properties>
</file>